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8371ED-A639-4A43-B088-838FE25970B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C18326-AD25-41C0-B321-4F623B1CBE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060A3-A4DC-4D69-89CE-8224E7B238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C9223-EBAA-43B0-A9E4-F49DF71978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E1174B-D036-443C-8B9B-FB9650B486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50E1A-C9B4-4D91-8B9C-EDB73C524B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E83CCE-35C5-4598-8DB4-1FDF690AA4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998D4-73D0-448D-8331-E3318CC390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73EB1-81AB-4938-A06F-C88A754D4F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31DAE-B5EE-422B-9592-EB5CD0E8CB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C1F6A6-0B0F-4AA1-B52C-9A266D966F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C885CB-50F9-4A34-BFDB-3E6EAC0A10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4D9CD3-A621-47AE-817E-C9B027A51B52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36480" y="8031240"/>
            <a:ext cx="5699160" cy="71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ipose tissue and liver gene expressio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Adipose tissue and liver mRNA levels from differen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enes from 5-wk-age female wild type, ob/ob, PPAR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 KO and POKO mice (n=6-8)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 P&lt;0.05, ** P&lt;0.01 and  *** P&lt;0.001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POKO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v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ob/ob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128600" y="406440"/>
            <a:ext cx="4819680" cy="4118040"/>
            <a:chOff x="1128600" y="406440"/>
            <a:chExt cx="4819680" cy="4118040"/>
          </a:xfrm>
        </p:grpSpPr>
        <p:sp>
          <p:nvSpPr>
            <p:cNvPr id="43" name=""/>
            <p:cNvSpPr/>
            <p:nvPr/>
          </p:nvSpPr>
          <p:spPr>
            <a:xfrm>
              <a:off x="1909800" y="3867120"/>
              <a:ext cx="9360" cy="1206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905120" y="3862440"/>
              <a:ext cx="7920" cy="120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909800" y="3200400"/>
              <a:ext cx="361800" cy="1206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905120" y="3195360"/>
              <a:ext cx="361800" cy="1209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909800" y="2531880"/>
              <a:ext cx="1066680" cy="1224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905120" y="2527200"/>
              <a:ext cx="1066680" cy="1224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909800" y="1868400"/>
              <a:ext cx="296640" cy="1206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905120" y="1863720"/>
              <a:ext cx="295200" cy="120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909800" y="1201680"/>
              <a:ext cx="957240" cy="1206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905120" y="1197000"/>
              <a:ext cx="957240" cy="120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909800" y="3743280"/>
              <a:ext cx="171360" cy="12384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905120" y="3738600"/>
              <a:ext cx="169560" cy="1238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909800" y="3076560"/>
              <a:ext cx="1130400" cy="12384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905120" y="3070080"/>
              <a:ext cx="1131840" cy="1252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909800" y="2411280"/>
              <a:ext cx="1644480" cy="1206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905120" y="2406600"/>
              <a:ext cx="1644480" cy="120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909800" y="1744560"/>
              <a:ext cx="2041560" cy="12384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905120" y="1739880"/>
              <a:ext cx="2039760" cy="1238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909800" y="1077840"/>
              <a:ext cx="1647720" cy="12384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905120" y="1071360"/>
              <a:ext cx="1645920" cy="1256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909800" y="3622680"/>
              <a:ext cx="71280" cy="120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905120" y="3616200"/>
              <a:ext cx="71280" cy="1224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909800" y="2955960"/>
              <a:ext cx="755640" cy="120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905120" y="2949480"/>
              <a:ext cx="755640" cy="120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909800" y="2290680"/>
              <a:ext cx="1457280" cy="120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905120" y="2286000"/>
              <a:ext cx="1455480" cy="120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909800" y="1623960"/>
              <a:ext cx="620640" cy="120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905120" y="1617480"/>
              <a:ext cx="618840" cy="1224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909800" y="957240"/>
              <a:ext cx="982440" cy="120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905120" y="950760"/>
              <a:ext cx="981000" cy="120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909800" y="3502080"/>
              <a:ext cx="1535040" cy="120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905120" y="3495600"/>
              <a:ext cx="1533240" cy="120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909800" y="2833560"/>
              <a:ext cx="1535040" cy="122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905120" y="2828880"/>
              <a:ext cx="1533240" cy="120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909800" y="2170080"/>
              <a:ext cx="1535040" cy="120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905120" y="2163600"/>
              <a:ext cx="1533240" cy="1224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909800" y="1503360"/>
              <a:ext cx="1535040" cy="120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905120" y="1496880"/>
              <a:ext cx="1533240" cy="120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909800" y="834840"/>
              <a:ext cx="1535040" cy="122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905120" y="830160"/>
              <a:ext cx="1533240" cy="120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913040" y="3921120"/>
              <a:ext cx="14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913040" y="3886200"/>
              <a:ext cx="144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266920" y="3254400"/>
              <a:ext cx="460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313000" y="3219480"/>
              <a:ext cx="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2971800" y="2585520"/>
              <a:ext cx="950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066840" y="2552760"/>
              <a:ext cx="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200320" y="1922400"/>
              <a:ext cx="60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260440" y="1887480"/>
              <a:ext cx="180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862360" y="1255680"/>
              <a:ext cx="118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979720" y="1220760"/>
              <a:ext cx="144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074680" y="3797280"/>
              <a:ext cx="511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125800" y="3762360"/>
              <a:ext cx="144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036960" y="3130560"/>
              <a:ext cx="1252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162240" y="3095640"/>
              <a:ext cx="144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549600" y="2465280"/>
              <a:ext cx="1094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659040" y="2430360"/>
              <a:ext cx="180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944880" y="1801800"/>
              <a:ext cx="298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238640" y="1766880"/>
              <a:ext cx="144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3551040" y="1135080"/>
              <a:ext cx="1447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695760" y="1100160"/>
              <a:ext cx="144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976400" y="3674880"/>
              <a:ext cx="2052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1996920" y="3639960"/>
              <a:ext cx="180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660760" y="3008160"/>
              <a:ext cx="106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766960" y="2973240"/>
              <a:ext cx="144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360600" y="2344680"/>
              <a:ext cx="1080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468600" y="2309760"/>
              <a:ext cx="180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523960" y="1677960"/>
              <a:ext cx="1080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631960" y="1643040"/>
              <a:ext cx="180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886120" y="1009440"/>
              <a:ext cx="18576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071880" y="974520"/>
              <a:ext cx="144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438360" y="3554280"/>
              <a:ext cx="304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741840" y="3519360"/>
              <a:ext cx="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438360" y="2887560"/>
              <a:ext cx="2620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700440" y="2852640"/>
              <a:ext cx="0" cy="7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3438360" y="2222280"/>
              <a:ext cx="222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651120" y="2187360"/>
              <a:ext cx="0" cy="68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438360" y="1555560"/>
              <a:ext cx="241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678120" y="1520640"/>
              <a:ext cx="180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438360" y="888840"/>
              <a:ext cx="25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686040" y="853920"/>
              <a:ext cx="1800" cy="6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1893960" y="4078080"/>
              <a:ext cx="3065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"/>
            <p:cNvSpPr/>
            <p:nvPr/>
          </p:nvSpPr>
          <p:spPr>
            <a:xfrm flipV="1">
              <a:off x="1893960" y="4078080"/>
              <a:ext cx="1440" cy="28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"/>
            <p:cNvSpPr/>
            <p:nvPr/>
          </p:nvSpPr>
          <p:spPr>
            <a:xfrm flipV="1">
              <a:off x="2660760" y="4078080"/>
              <a:ext cx="1440" cy="28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"/>
            <p:cNvSpPr/>
            <p:nvPr/>
          </p:nvSpPr>
          <p:spPr>
            <a:xfrm flipV="1">
              <a:off x="3429000" y="4078080"/>
              <a:ext cx="0" cy="28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4192560" y="4078080"/>
              <a:ext cx="1440" cy="28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"/>
            <p:cNvSpPr/>
            <p:nvPr/>
          </p:nvSpPr>
          <p:spPr>
            <a:xfrm flipV="1">
              <a:off x="4959360" y="4078080"/>
              <a:ext cx="1440" cy="28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893960" y="744480"/>
              <a:ext cx="1440" cy="33336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1863720" y="4078080"/>
              <a:ext cx="30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1863720" y="3409920"/>
              <a:ext cx="3024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863720" y="2743200"/>
              <a:ext cx="3024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1863720" y="2077920"/>
              <a:ext cx="3024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863720" y="1411200"/>
              <a:ext cx="3024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863720" y="744480"/>
              <a:ext cx="3024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3086280" y="406440"/>
              <a:ext cx="632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WAT 5wk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860120" y="41670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575800" y="41670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3395160" y="41670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4106160" y="41670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4925520" y="41670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371600" y="3671640"/>
              <a:ext cx="465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dipsi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128600" y="3004920"/>
              <a:ext cx="733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diponecti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569960" y="23382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P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497960" y="1673280"/>
              <a:ext cx="32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lut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330560" y="1006200"/>
              <a:ext cx="493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PAR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3013560" y="4371840"/>
              <a:ext cx="1188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5187960" y="2131920"/>
              <a:ext cx="63360" cy="61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5184720" y="2128680"/>
              <a:ext cx="68400" cy="684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5274000" y="210348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5187960" y="2292120"/>
              <a:ext cx="63360" cy="63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5184720" y="2290680"/>
              <a:ext cx="68400" cy="66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5264640" y="2265120"/>
              <a:ext cx="683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PAR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K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5187960" y="2455920"/>
              <a:ext cx="63360" cy="619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5184720" y="2452680"/>
              <a:ext cx="68400" cy="66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5273280" y="2425680"/>
              <a:ext cx="34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ob/o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5187960" y="2616120"/>
              <a:ext cx="63360" cy="6192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5184720" y="2614680"/>
              <a:ext cx="68400" cy="666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5273280" y="2585880"/>
              <a:ext cx="374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K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3026160" y="1197000"/>
              <a:ext cx="278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2296440" y="1868400"/>
              <a:ext cx="326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3087000" y="2525760"/>
              <a:ext cx="326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2374200" y="3198600"/>
              <a:ext cx="326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1967040" y="3848040"/>
              <a:ext cx="22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65" name=""/>
          <p:cNvGrpSpPr/>
          <p:nvPr/>
        </p:nvGrpSpPr>
        <p:grpSpPr>
          <a:xfrm>
            <a:off x="1348560" y="4979880"/>
            <a:ext cx="3973320" cy="2994120"/>
            <a:chOff x="1348560" y="4979880"/>
            <a:chExt cx="3973320" cy="2994120"/>
          </a:xfrm>
        </p:grpSpPr>
        <p:sp>
          <p:nvSpPr>
            <p:cNvPr id="166" name=""/>
            <p:cNvSpPr/>
            <p:nvPr/>
          </p:nvSpPr>
          <p:spPr>
            <a:xfrm>
              <a:off x="1890720" y="7303680"/>
              <a:ext cx="2187720" cy="131760"/>
            </a:xfrm>
            <a:prstGeom prst="rect">
              <a:avLst/>
            </a:prstGeom>
            <a:solidFill>
              <a:srgbClr val="c0c0c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1887480" y="7295760"/>
              <a:ext cx="2187720" cy="1317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1881360" y="6580080"/>
              <a:ext cx="1623960" cy="133200"/>
            </a:xfrm>
            <a:prstGeom prst="rect">
              <a:avLst/>
            </a:prstGeom>
            <a:solidFill>
              <a:srgbClr val="c0c0c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1878120" y="6573600"/>
              <a:ext cx="1623960" cy="1317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1881360" y="5857560"/>
              <a:ext cx="1492200" cy="131760"/>
            </a:xfrm>
            <a:prstGeom prst="rect">
              <a:avLst/>
            </a:prstGeom>
            <a:solidFill>
              <a:srgbClr val="c0c0c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1878120" y="5851080"/>
              <a:ext cx="1492200" cy="1317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1890720" y="7170480"/>
              <a:ext cx="1324080" cy="133200"/>
            </a:xfrm>
            <a:prstGeom prst="rect">
              <a:avLst/>
            </a:prstGeom>
            <a:solidFill>
              <a:srgbClr val="80808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1887480" y="7164000"/>
              <a:ext cx="1322280" cy="1317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1881360" y="6448320"/>
              <a:ext cx="1436400" cy="131760"/>
            </a:xfrm>
            <a:prstGeom prst="rect">
              <a:avLst/>
            </a:prstGeom>
            <a:solidFill>
              <a:srgbClr val="80808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1878120" y="6441840"/>
              <a:ext cx="1434960" cy="1317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1881360" y="5725800"/>
              <a:ext cx="1344600" cy="131760"/>
            </a:xfrm>
            <a:prstGeom prst="rect">
              <a:avLst/>
            </a:prstGeom>
            <a:solidFill>
              <a:srgbClr val="80808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1878120" y="5719320"/>
              <a:ext cx="1342800" cy="1317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1890720" y="7041960"/>
              <a:ext cx="1622520" cy="1285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1887480" y="7035480"/>
              <a:ext cx="1622520" cy="128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1881360" y="6319440"/>
              <a:ext cx="1852560" cy="1288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1878120" y="6313320"/>
              <a:ext cx="1852560" cy="128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881360" y="5597280"/>
              <a:ext cx="1576080" cy="12852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878120" y="5590800"/>
              <a:ext cx="1576440" cy="128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890720" y="6910200"/>
              <a:ext cx="2363760" cy="1317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887480" y="6903720"/>
              <a:ext cx="2363760" cy="1317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881360" y="6187680"/>
              <a:ext cx="2363760" cy="1317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1878120" y="6181560"/>
              <a:ext cx="2363760" cy="1317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1881360" y="5465520"/>
              <a:ext cx="2363760" cy="1317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1878120" y="5457600"/>
              <a:ext cx="2363760" cy="1332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4075200" y="7362720"/>
              <a:ext cx="388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4462560" y="7316640"/>
              <a:ext cx="1440" cy="90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3502080" y="6640200"/>
              <a:ext cx="2458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3747960" y="6594120"/>
              <a:ext cx="1800" cy="90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3370320" y="5916240"/>
              <a:ext cx="114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3484440" y="5871960"/>
              <a:ext cx="1800" cy="90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3209760" y="7230960"/>
              <a:ext cx="79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3289320" y="7184880"/>
              <a:ext cx="1440" cy="90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3313080" y="6507000"/>
              <a:ext cx="130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3443400" y="6462360"/>
              <a:ext cx="1440" cy="90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3220920" y="5784480"/>
              <a:ext cx="1224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3343320" y="5740200"/>
              <a:ext cx="1440" cy="90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3510000" y="7097400"/>
              <a:ext cx="193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3703680" y="7053120"/>
              <a:ext cx="0" cy="90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3730680" y="6375240"/>
              <a:ext cx="47952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210200" y="6338520"/>
              <a:ext cx="1440" cy="90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3454560" y="5652720"/>
              <a:ext cx="11880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3573360" y="5608440"/>
              <a:ext cx="1800" cy="88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4251240" y="6965640"/>
              <a:ext cx="4604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711680" y="6921360"/>
              <a:ext cx="1440" cy="90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4241880" y="6243480"/>
              <a:ext cx="3744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4616280" y="6198840"/>
              <a:ext cx="1800" cy="88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4241880" y="5520960"/>
              <a:ext cx="299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4540320" y="5474880"/>
              <a:ext cx="1440" cy="90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1881360" y="7532280"/>
              <a:ext cx="33112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5" name=""/>
            <p:cNvSpPr/>
            <p:nvPr/>
          </p:nvSpPr>
          <p:spPr>
            <a:xfrm flipV="1">
              <a:off x="1881360" y="753192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6" name=""/>
            <p:cNvSpPr/>
            <p:nvPr/>
          </p:nvSpPr>
          <p:spPr>
            <a:xfrm flipV="1">
              <a:off x="2354400" y="753192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7" name=""/>
            <p:cNvSpPr/>
            <p:nvPr/>
          </p:nvSpPr>
          <p:spPr>
            <a:xfrm flipV="1">
              <a:off x="2827440" y="753192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8" name=""/>
            <p:cNvSpPr/>
            <p:nvPr/>
          </p:nvSpPr>
          <p:spPr>
            <a:xfrm flipV="1">
              <a:off x="3301920" y="7531920"/>
              <a:ext cx="180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9" name=""/>
            <p:cNvSpPr/>
            <p:nvPr/>
          </p:nvSpPr>
          <p:spPr>
            <a:xfrm flipV="1">
              <a:off x="3772080" y="753192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0" name=""/>
            <p:cNvSpPr/>
            <p:nvPr/>
          </p:nvSpPr>
          <p:spPr>
            <a:xfrm flipH="1" flipV="1">
              <a:off x="4246200" y="7531920"/>
              <a:ext cx="468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1" name=""/>
            <p:cNvSpPr/>
            <p:nvPr/>
          </p:nvSpPr>
          <p:spPr>
            <a:xfrm flipV="1">
              <a:off x="4721400" y="7531920"/>
              <a:ext cx="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2" name=""/>
            <p:cNvSpPr/>
            <p:nvPr/>
          </p:nvSpPr>
          <p:spPr>
            <a:xfrm flipV="1">
              <a:off x="5192640" y="7531920"/>
              <a:ext cx="180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1881360" y="5364000"/>
              <a:ext cx="1440" cy="2168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1862280" y="7532280"/>
              <a:ext cx="190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1862280" y="681012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1862280" y="608796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1862280" y="5364000"/>
              <a:ext cx="190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3067560" y="4979880"/>
              <a:ext cx="57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iver 5wk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1863360" y="76276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2307600" y="76276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2782080" y="76276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3255120" y="76276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725280" y="76276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4227120" y="76276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4672800" y="76276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5145840" y="76276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1440720" y="7099200"/>
              <a:ext cx="25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6P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1348560" y="6376680"/>
              <a:ext cx="43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EPCK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1355400" y="5652720"/>
              <a:ext cx="424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GC1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3315240" y="7821360"/>
              <a:ext cx="1188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elative expression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4588200" y="7275240"/>
              <a:ext cx="22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42" name=""/>
          <p:cNvSpPr/>
          <p:nvPr/>
        </p:nvSpPr>
        <p:spPr>
          <a:xfrm>
            <a:off x="5419080" y="8704440"/>
            <a:ext cx="87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3" name=""/>
          <p:cNvSpPr/>
          <p:nvPr/>
        </p:nvSpPr>
        <p:spPr>
          <a:xfrm>
            <a:off x="755640" y="4675320"/>
            <a:ext cx="1843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2-09T18:50:00Z</dcterms:created>
  <dc:creator>Antonio Vidal-Puig</dc:creator>
  <dc:description/>
  <dc:language>en-US</dc:language>
  <cp:lastModifiedBy>Antonio Vidal-Puig</cp:lastModifiedBy>
  <dcterms:modified xsi:type="dcterms:W3CDTF">2007-03-05T17:15:30Z</dcterms:modified>
  <cp:revision>64</cp:revision>
  <dc:subject/>
  <dc:title>PowerPoint Presentation</dc:title>
</cp:coreProperties>
</file>